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9AF25C-F839-44ED-A75E-EC85CB16D2F1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62CFEB-CCED-4672-A495-DD84EBF94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738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EFE7DA-0180-4025-9F12-485CEC02CD1D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4802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498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873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014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454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643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8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51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616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169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552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128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858E99-3CF3-4B6F-AD29-E1B41984A165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1D7F5C-D5E4-4913-BAAF-41A3E4E4D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000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bpoonkuzhali@cmcvellore.ac.in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80F71ED6-F80A-46D0-9B62-E61BB08A36E7}"/>
              </a:ext>
            </a:extLst>
          </p:cNvPr>
          <p:cNvSpPr/>
          <p:nvPr/>
        </p:nvSpPr>
        <p:spPr>
          <a:xfrm>
            <a:off x="38363" y="36367"/>
            <a:ext cx="12120979" cy="66787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rgbClr val="32313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lasma imatinib levels and ABCB1 polymorphism influences early molecular response and failure-free survival in newly diagnosed chronic phase CML patients</a:t>
            </a:r>
            <a:endParaRPr lang="en-IN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harathi M. Rajamani, Esther Sathya Bama Benjamin, Aby Abraham, Sukanya Ganesan, Kavitha M Lakshmi,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nthamizhselvi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, Sreeja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rathedath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avitha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ratharajan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zhilpavai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hanan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Nancy Beryl Janet, Vivi M. Srivastava,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aji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amachandran V, Uday P Kulkarni, Anup J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vasia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ouzia NA, Anu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orula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Biju George, Alok Srivastava, Vikram Mathews and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onkuzhali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lasubramanian*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Department of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ematology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hristian medical college, Vellore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* Correspondence to: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onkuzhali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lasubramanian, Ph. D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fessor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</a:t>
            </a:r>
            <a:r>
              <a:rPr lang="en-US" sz="14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ematology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ristian Medical College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llore- 632004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-mail: </a:t>
            </a:r>
            <a:r>
              <a:rPr lang="en-US" sz="1400" u="sng" dirty="0">
                <a:solidFill>
                  <a:srgbClr val="0000FF"/>
                </a:solidFill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  <a:hlinkClick r:id="rId2"/>
              </a:rPr>
              <a:t>bpoonkuzhali@cmcvellore.ac.in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one: 91-416-2283476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x: 91-416-2226449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000000"/>
                </a:solidFill>
                <a:latin typeface="Calibri,Bold"/>
                <a:ea typeface="Calibri" panose="020F0502020204030204" pitchFamily="34" charset="0"/>
                <a:cs typeface="Calibri,Bold"/>
              </a:rPr>
              <a:t>Acknowledgement: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This study is supported by Department of Biotechnology India-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rogramme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support grant: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BT/01/COE/08/03; Centre of Excellence grant from Department of Biotechnology India: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BT/COE/34/SP13432/2015 and Indian Council of Medical Research Centre for Advanced Research grant </a:t>
            </a:r>
            <a:r>
              <a:rPr lang="en-US" sz="1400" dirty="0">
                <a:solidFill>
                  <a:srgbClr val="2B2B2D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70/14/14-CAR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to Dr.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oonkuzhali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Balasubramanian.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RVS, VM and PB are supported by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Wellcome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DBT India Alliance (IA/S/17/1/503118, IA/CPHS/18/1/503930 and IA/S/15/1/501842) respectively.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UK is supported by an early career fellowship program of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Wellcome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DBT India Alliance (IA/CPHE/17/1/503351), Government of India. 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K is supported by University Grants Commission, ESB by DST Inspire fellowship and SV by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Indian Council of Medical Research, Government of India.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We sincerely acknowledge the encouragement and support provided by Dr.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Mammen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handy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rofessor and Former Head, Department of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aematology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CMC Vellore, currently Director, Tata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Medical Centre, Kolkata in the initial stages of this study.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The help provided by Ms.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reetha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Markose &amp; Dr. Ajay Abraham in the initial stages of this study, Mr. Christopher Benjamin, Mr.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elvakumar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Ms.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Kalaiselvi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in CML patient recruitment for the study and by Dr. Eunice S. Edison in managing the DNA sequencing core facility are gratefully acknowledged.</a:t>
            </a:r>
            <a:endParaRPr lang="en-IN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32401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/>
          <p:cNvSpPr/>
          <p:nvPr/>
        </p:nvSpPr>
        <p:spPr>
          <a:xfrm>
            <a:off x="952500" y="0"/>
            <a:ext cx="21546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b="1">
                <a:cs typeface="Arial" pitchFamily="34" charset="0"/>
              </a:rPr>
              <a:t>Supplementary </a:t>
            </a:r>
            <a:r>
              <a:rPr lang="en-US" altLang="en-US" b="1" dirty="0">
                <a:cs typeface="Arial" pitchFamily="34" charset="0"/>
              </a:rPr>
              <a:t>Fig-1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206432" y="4918398"/>
            <a:ext cx="1132193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1: EMR &amp; MMR status influence FFS after imatinib therapy in patients with CP-CML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Influence of early molecular response at (a) 3 &amp; (b) 6 months and (c) major molecular response at 12 months on FFS after imatinib therapy. Statistical significance was calculated using Cox-regression analysis. 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53E19DFB-ED59-48B3-9F27-5A32F01E471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884" y="1008154"/>
            <a:ext cx="11000232" cy="26273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4894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439</Words>
  <Application>Microsoft Office PowerPoint</Application>
  <PresentationFormat>Widescreen</PresentationFormat>
  <Paragraphs>29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alibri,Bold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ONKUZHALI</dc:creator>
  <cp:lastModifiedBy>bharathi</cp:lastModifiedBy>
  <cp:revision>10</cp:revision>
  <dcterms:created xsi:type="dcterms:W3CDTF">2020-03-30T09:54:43Z</dcterms:created>
  <dcterms:modified xsi:type="dcterms:W3CDTF">2020-09-24T15:32:44Z</dcterms:modified>
</cp:coreProperties>
</file>